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1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EA4BDB-7088-448C-A562-4FD58A350A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43D8F11-19C9-449D-BCC2-91323779B1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72AFE9-DF46-4B9F-8117-0F8567C99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AE90B2-E82E-4B4A-A75D-1DF450F9E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939484-59EC-473C-99F6-C36F0E08C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724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C6D4D3-9EE0-40A7-B50E-F9F82FB685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730AB6B-02C7-4201-ABD2-D54DB29A44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0757EC-8F60-4252-9C1E-08C9DF5FC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A33C87-662F-4C7C-A301-45127FD9A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562E83-0853-43FC-88EB-1DF6020C0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564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D39B02C-09B2-4C40-B0E9-8A72C367F5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1F03CD7-ECD3-4F84-B857-587E85BD81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D18651-9BB7-4768-93EB-BDE6BE456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C389EB-CB5E-469D-BC5F-8DAB82FC1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D49B89-5CF6-4D35-A94C-1AA1A6481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942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0CBFAE-C5B9-4032-A411-DA708DC58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1065EA-597F-4A7A-BB4D-35B090591C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640F64-FD31-455B-87BC-608DEDF80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798DD3-43CC-42FD-980D-7572EE29B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318173-9BA4-42F9-8EAA-5830B5F2A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676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EA528B-81FF-4F22-81F8-8959F3677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58A84A-854C-4BAE-9657-B0589B6FC7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9805B3-B972-47F5-B032-6D9CFAFB7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4D0460-631D-46FE-9445-4516CE48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50BA03-924E-4FB9-B730-00AC3AE0A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465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063881-9851-4D48-9E3E-BEEA13C08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6004EC0-538B-4A6B-973E-868F53AE12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809847D-F748-46F1-A9EC-8B21CC7EAB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079B32-9310-4F40-B6A1-C6E3634D6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0289AD-28BB-4415-9C30-8BA5ACDB3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AC2F92-8CA7-48F9-88F2-A4D63C756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636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D3BB9F-92A2-4C1F-9D33-60C7266B0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75A5A3-95D8-4268-8972-015D2348B4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7FE61C9-5DAC-4FF5-A8D4-7E024150CB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16510DF-CA4B-4C6A-8962-6E505AE061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ACC76E6-73C7-480F-A590-35F51EE320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8DF6612-D4D3-44A4-8569-279323612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5EA3F54-396B-4DFE-9A94-39F73BCE1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9061CDC-1A69-4130-BD17-8A4EA6E4D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119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F66923-CCF0-42E7-A978-71C758603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BC936D0-1FC0-4F0C-8F22-35C3EF5AF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11D34D0-F89D-4734-9C8C-D8226C24F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8D67CB6-8667-4852-8EB2-119403210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2556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6BAB226-6533-4062-ACE1-712B67C5D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407205C-F34B-416A-B3EA-599A9B809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A3465E5-DD4E-4043-BDA9-F906FB502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561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12A0B-FF0B-4644-A70F-EC0DEA0FF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8ACD34C-32D1-4084-A27C-AFAC70E7E1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1040D0E-9E45-4412-B879-7362A3F978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211921-FC8A-4273-AFA8-A124CB862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068729-54EE-42C1-A49A-79E6E0CFE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C03C45-7838-405C-9F8D-2A5327189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09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FC7E77-BD32-416B-8858-0746B69AA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4889750-DE37-4AA3-8BCD-BCDBC8A2FD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42BB0F-9F79-4B35-B95A-03C2BA9339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44DD46A-94D7-49CD-9024-0DBC17261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43B319-3F2A-4263-9A5B-0C182F63C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C166B1-AB6A-423C-869A-30397F57F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7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42B1D9C-E4EB-4080-A0D9-2FEF3A82C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F4BC59-8C59-426A-9DAC-DE0592388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0C60EA-4412-44C4-95E0-41D6106EC6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CA5A7-041E-418B-A276-A2BE5F4AC28E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A5D041-2074-401C-9702-365BB769E8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3C6A39-030D-4394-A260-FD80AE572B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F3DE1-7DF1-4B66-82AA-FDF686561A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7692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8D05B092-D3A3-4A5C-9C90-C4F6E2D673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037719"/>
              </p:ext>
            </p:extLst>
          </p:nvPr>
        </p:nvGraphicFramePr>
        <p:xfrm>
          <a:off x="2109056" y="199053"/>
          <a:ext cx="7973887" cy="60908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89085">
                  <a:extLst>
                    <a:ext uri="{9D8B030D-6E8A-4147-A177-3AD203B41FA5}">
                      <a16:colId xmlns:a16="http://schemas.microsoft.com/office/drawing/2014/main" val="3061421858"/>
                    </a:ext>
                  </a:extLst>
                </a:gridCol>
                <a:gridCol w="61217">
                  <a:extLst>
                    <a:ext uri="{9D8B030D-6E8A-4147-A177-3AD203B41FA5}">
                      <a16:colId xmlns:a16="http://schemas.microsoft.com/office/drawing/2014/main" val="2437837078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2567511037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1097643306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2818941754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1153167663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943926960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2532288258"/>
                    </a:ext>
                  </a:extLst>
                </a:gridCol>
                <a:gridCol w="203636">
                  <a:extLst>
                    <a:ext uri="{9D8B030D-6E8A-4147-A177-3AD203B41FA5}">
                      <a16:colId xmlns:a16="http://schemas.microsoft.com/office/drawing/2014/main" val="542491925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2052006447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4174338631"/>
                    </a:ext>
                  </a:extLst>
                </a:gridCol>
                <a:gridCol w="746661">
                  <a:extLst>
                    <a:ext uri="{9D8B030D-6E8A-4147-A177-3AD203B41FA5}">
                      <a16:colId xmlns:a16="http://schemas.microsoft.com/office/drawing/2014/main" val="2356654512"/>
                    </a:ext>
                  </a:extLst>
                </a:gridCol>
              </a:tblGrid>
              <a:tr h="320264">
                <a:tc gridSpan="12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eatability: %Reticulocyt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7685792"/>
                  </a:ext>
                </a:extLst>
              </a:tr>
              <a:tr h="2165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alu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limina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rehens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6846436"/>
                  </a:ext>
                </a:extLst>
              </a:tr>
              <a:tr h="2444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8252066"/>
                  </a:ext>
                </a:extLst>
              </a:tr>
              <a:tr h="1536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92102331"/>
                  </a:ext>
                </a:extLst>
              </a:tr>
              <a:tr h="1536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966615548"/>
                  </a:ext>
                </a:extLst>
              </a:tr>
              <a:tr h="2025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C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L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L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189095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3502687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494926944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3519179325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604950782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4015311774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2804217437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2355607651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3483558223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10639701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3725032347"/>
                  </a:ext>
                </a:extLst>
              </a:tr>
              <a:tr h="242403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9717809"/>
                  </a:ext>
                </a:extLst>
              </a:tr>
              <a:tr h="342180">
                <a:tc gridSpan="12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eatability: Reticulocyte (10</a:t>
                      </a:r>
                      <a:r>
                        <a:rPr lang="en-US" sz="160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29352"/>
                  </a:ext>
                </a:extLst>
              </a:tr>
              <a:tr h="2165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alu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limina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rehens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5738957"/>
                  </a:ext>
                </a:extLst>
              </a:tr>
              <a:tr h="2444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54856740"/>
                  </a:ext>
                </a:extLst>
              </a:tr>
              <a:tr h="1536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9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09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6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0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65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9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1504814781"/>
                  </a:ext>
                </a:extLst>
              </a:tr>
              <a:tr h="1536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860639264"/>
                  </a:ext>
                </a:extLst>
              </a:tr>
              <a:tr h="2025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C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1132650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5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6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69263682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1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3732380655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4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9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2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8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6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88734188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2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3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2054345458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2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9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5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1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2095266923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6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0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9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9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3794280620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9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5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4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4283327728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2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0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4232085486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0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2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9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845076392"/>
                  </a:ext>
                </a:extLst>
              </a:tr>
              <a:tr h="1345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4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0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5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1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6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5841" marR="5841" marT="5841" marB="0" anchor="ctr"/>
                </a:tc>
                <a:extLst>
                  <a:ext uri="{0D108BD9-81ED-4DB2-BD59-A6C34878D82A}">
                    <a16:rowId xmlns:a16="http://schemas.microsoft.com/office/drawing/2014/main" val="533904508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DBDA2EB-E829-4A20-88EA-172A8FE3811B}"/>
              </a:ext>
            </a:extLst>
          </p:cNvPr>
          <p:cNvSpPr txBox="1"/>
          <p:nvPr/>
        </p:nvSpPr>
        <p:spPr>
          <a:xfrm>
            <a:off x="1872339" y="6412726"/>
            <a:ext cx="8082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ppendix</a:t>
            </a:r>
            <a:r>
              <a:rPr lang="ja-JP" altLang="en-US" sz="1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.  Repeatability</a:t>
            </a:r>
            <a:endParaRPr kumimoji="1" lang="ja-JP" altLang="en-US" sz="10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1034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304</Words>
  <Application>Microsoft Office PowerPoint</Application>
  <PresentationFormat>ワイド画面</PresentationFormat>
  <Paragraphs>28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tk.nagai@gmail.com</dc:creator>
  <cp:lastModifiedBy>ytk.nagai@gmail.com</cp:lastModifiedBy>
  <cp:revision>6</cp:revision>
  <dcterms:created xsi:type="dcterms:W3CDTF">2021-11-15T23:50:52Z</dcterms:created>
  <dcterms:modified xsi:type="dcterms:W3CDTF">2022-01-07T04:47:02Z</dcterms:modified>
</cp:coreProperties>
</file>